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6" d="100"/>
          <a:sy n="56" d="100"/>
        </p:scale>
        <p:origin x="1000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4F9BCF-28C3-4B2F-ABB9-06F39BCA962B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4F3678-5EB3-490A-8B9C-129FA91F841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80803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E5E1A77-8358-1FED-FE29-6C8828B5D9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1A3D88B-DF08-DC3C-813A-9ABA95F1CB0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CA4B0FE-D61B-237F-2528-FCE6B859479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T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6357A1-950F-4C6D-1E34-EC4E8B39486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067A35-0CCD-7042-839E-B9971C50DAFD}" type="slidenum">
              <a:rPr lang="en-IT" smtClean="0"/>
              <a:t>1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12956575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D932FDE-D6E9-0B2C-8008-1EB39C81F5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BA1FEFD-CA4A-DCD8-7AAF-77146FFFD5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A2AAD2-9471-553E-7A47-9053168E4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C54E021-01EE-AEA1-6EA9-6EEB870EB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0BFF884-6B55-BBA6-ECB0-ED691C8FD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5524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E3F43F-69D2-F737-89E3-9B2B1DEBE4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19D0294-6A0B-885F-FB00-2BC3BA3149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593595-AFE5-BF30-2848-735B648AC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181EA3-EB3B-2841-9D9D-667D26A78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9E8DD35-3EA4-34E4-42BD-32A514268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7190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3C7E232-E4C2-BBE4-DBE7-6BF38C58CF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2CEEB9D-7731-ED66-495C-1B89541C00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FD9F770-0D3D-4A87-FF4F-4D1B1AA0C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67FED51-07E4-FB1F-65E6-A1CD8089D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55C9F4-7A31-302C-D430-5C1FB6915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5361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392718-C8AB-8C3C-D4B5-17D4D761B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0A548A6-5889-34DD-16F6-B648B98CB7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728C536-6826-0276-A6F3-FA4EF62A8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7C9E2BF-AE57-5086-B33E-45A2743CB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2AA5EEC-FCC0-B813-C01C-1F508489B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4640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24CEDB-B3D3-27D1-A722-48240F00AE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EE10014-E425-F393-B0A8-818BB061D4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F7AD4F-1699-CF71-4EC2-B708C8410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99F62C7-AE35-288F-6B16-A7D48BB3F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B12C75-376B-9691-271D-96BB0A170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4073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672AED9-0504-C6FF-B35E-BCA75A038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7D5D68-546D-FDA8-3C52-81AE704BA5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F149A24-F7FB-FE8D-7AF3-164082B06A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A372F42-42CD-16DE-F1F8-D3545F60E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07B29B8-2F82-2914-54E4-9962F4F11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DFA238A-E3F5-70AB-05A4-B484539E3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1868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622BA73-33EF-2B7F-4543-54AC21F5E2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F009FCB-AF4A-CAD5-141C-3BBAD42BAE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63AAAF9-159F-38A3-1D5E-F8579679C5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D216D01-DE13-B754-8192-7B9FDC010B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EDB5C53-D397-18EB-8354-54CFAA37E1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7381C80-41A6-FAF3-98E7-32755699C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AF5D973-9FC7-02A0-07CD-0A3F9ED170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D00E1708-0FA8-1FD8-A78A-4E11DC0A6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3440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C811FAB-46FC-CE4C-6557-D3B3F405F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CC33DF8-8186-E99E-243B-2742A0932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59F66B3-6994-5B97-ED95-2A4C7291BF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3411C30-4227-D970-10E8-1361C2B95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656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F402E12-50FC-48D0-49A3-FB75F6E4F5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06B0BC0B-03CD-F7E8-9455-05240F26B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7BDBA70-493E-0556-854E-6A473C335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4690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B3E046A-12B5-83CC-5DD4-6F1EF5139B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8A83447-AC47-9A9E-273E-AA6EF7F43F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01864C0-1EDC-2126-BA69-39BFB4056A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43629C9-7AEA-FC14-0FD1-58D3857F4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00CAD2A-CAD6-8DC5-1123-9A4CDB806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F8928C7-1648-5C59-A6A0-34EFED3FC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8752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19D57B-41F5-E5B4-E44F-58F94023B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4778B54-8948-3C9A-F368-3B17269DBA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A6FB529-795E-0F81-074A-65963AC15E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440FDAD-8F4F-B364-E4F9-F98B386F5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E32A579-6E6B-778B-FC4E-FC4C71EB7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E62B694-B4E9-ED84-929D-425BB05CB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37072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AECD5A9-5783-BB97-10E6-E690FCB17E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9495C26-95FB-E5E0-1B0B-53EEDCE257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E2B6FA-D2EB-D53C-C3E8-D78E5594E5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DF60D-1219-4C82-A4D4-4600F66C13AA}" type="datetimeFigureOut">
              <a:rPr lang="it-IT" smtClean="0"/>
              <a:t>21/05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E7B04B5-7F04-65C2-042E-3EFBF49994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B8600A6-AAB2-6544-796F-A2881CE831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D62FB-510C-4BA3-85BE-53863F28BD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4517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FC2E83-C309-CD75-4B1D-2AFD96A40B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AD62DD3-88A5-8A6F-2946-E26540FF873A}"/>
              </a:ext>
            </a:extLst>
          </p:cNvPr>
          <p:cNvSpPr txBox="1"/>
          <p:nvPr/>
        </p:nvSpPr>
        <p:spPr>
          <a:xfrm>
            <a:off x="354522" y="195089"/>
            <a:ext cx="1118369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400" dirty="0"/>
              <a:t>Supplemental Figure 3: boxplot showing the distribution of Sarculator predicted overall survival (A, C) and Sarculator predicted disease free survival (B, D) at 5 years (A, B) and at 10 years (C, D) stratified by CINSARC risk category (blue, C1; yellow, C2). The median predicted OS/DFS is marked by the central horizontal line in each box with the box edges representing the interquartile range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841850-0F87-BC0D-3A0F-C6044263838F}"/>
              </a:ext>
            </a:extLst>
          </p:cNvPr>
          <p:cNvSpPr txBox="1"/>
          <p:nvPr/>
        </p:nvSpPr>
        <p:spPr>
          <a:xfrm>
            <a:off x="354522" y="10235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25A5238-01C9-210C-532E-75F465D7A65A}"/>
              </a:ext>
            </a:extLst>
          </p:cNvPr>
          <p:cNvSpPr txBox="1"/>
          <p:nvPr/>
        </p:nvSpPr>
        <p:spPr>
          <a:xfrm>
            <a:off x="354522" y="373838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B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ED091D1A-BEAF-B57E-207E-32BB9804DF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238" y="1208228"/>
            <a:ext cx="5244986" cy="524498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A75820F-6475-E038-9D18-E0A491ADF5DD}"/>
              </a:ext>
            </a:extLst>
          </p:cNvPr>
          <p:cNvSpPr txBox="1"/>
          <p:nvPr/>
        </p:nvSpPr>
        <p:spPr>
          <a:xfrm>
            <a:off x="6074867" y="102356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E3307-BBB2-9E8F-7C6C-A61D8862AF0D}"/>
              </a:ext>
            </a:extLst>
          </p:cNvPr>
          <p:cNvSpPr txBox="1"/>
          <p:nvPr/>
        </p:nvSpPr>
        <p:spPr>
          <a:xfrm>
            <a:off x="6074867" y="373838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T" dirty="0"/>
              <a:t>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8497ACA-51F2-F81B-FBD5-1AB177DF91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84567" y="1208228"/>
            <a:ext cx="5244986" cy="524498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FE9F43F-BAFB-C6F3-93CD-09B7079ABF97}"/>
              </a:ext>
            </a:extLst>
          </p:cNvPr>
          <p:cNvSpPr txBox="1"/>
          <p:nvPr/>
        </p:nvSpPr>
        <p:spPr>
          <a:xfrm>
            <a:off x="5133308" y="6114660"/>
            <a:ext cx="8627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p</a:t>
            </a:r>
            <a:r>
              <a:rPr lang="en-IT" sz="1600" dirty="0"/>
              <a:t>&lt;0.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252B254-89EC-C979-4E92-D8FDDE1BC7AF}"/>
              </a:ext>
            </a:extLst>
          </p:cNvPr>
          <p:cNvSpPr txBox="1"/>
          <p:nvPr/>
        </p:nvSpPr>
        <p:spPr>
          <a:xfrm>
            <a:off x="5054487" y="3584500"/>
            <a:ext cx="8627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p</a:t>
            </a:r>
            <a:r>
              <a:rPr lang="en-IT" sz="1600" dirty="0"/>
              <a:t>&lt;0.00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195D766-B1DE-1D93-842C-CDD966969165}"/>
              </a:ext>
            </a:extLst>
          </p:cNvPr>
          <p:cNvSpPr txBox="1"/>
          <p:nvPr/>
        </p:nvSpPr>
        <p:spPr>
          <a:xfrm>
            <a:off x="10846536" y="6114660"/>
            <a:ext cx="8627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p</a:t>
            </a:r>
            <a:r>
              <a:rPr lang="en-IT" sz="1600" dirty="0"/>
              <a:t>&lt;0.00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5BEE210-0C86-1C71-5D42-EA55222682FF}"/>
              </a:ext>
            </a:extLst>
          </p:cNvPr>
          <p:cNvSpPr txBox="1"/>
          <p:nvPr/>
        </p:nvSpPr>
        <p:spPr>
          <a:xfrm>
            <a:off x="10837961" y="3584500"/>
            <a:ext cx="8627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p</a:t>
            </a:r>
            <a:r>
              <a:rPr lang="en-IT" sz="1600" dirty="0"/>
              <a:t>&lt;0.001</a:t>
            </a:r>
          </a:p>
        </p:txBody>
      </p:sp>
    </p:spTree>
    <p:extLst>
      <p:ext uri="{BB962C8B-B14F-4D97-AF65-F5344CB8AC3E}">
        <p14:creationId xmlns:p14="http://schemas.microsoft.com/office/powerpoint/2010/main" val="27255619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asquali Sandro</dc:creator>
  <cp:lastModifiedBy>Pasquali Sandro</cp:lastModifiedBy>
  <cp:revision>1</cp:revision>
  <dcterms:created xsi:type="dcterms:W3CDTF">2025-05-21T11:09:14Z</dcterms:created>
  <dcterms:modified xsi:type="dcterms:W3CDTF">2025-05-21T11:09:30Z</dcterms:modified>
</cp:coreProperties>
</file>